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38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3CB68C-D6BF-2BAB-8F44-E2D93DCA2C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DA0B4DB-B95B-F488-7BDB-7ECCD1CBD2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30F77A-3E4D-170E-3876-67EA3E955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ECC586-F93F-82EA-9559-E1660F73C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644F29-485D-D095-5283-E9B362FB9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0404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6543D3-AF75-A7CA-A902-7911ACEA7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444945-66F4-7789-D799-751F38B1CA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3330C2-036E-4726-4219-CC8C9D6B9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2FF039-4551-1C5E-8909-2FB7A5613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C452A53-B749-7CB1-7B4D-53448D88C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7530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B6A5195-CAE0-3CBA-5837-4614750BA6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0D1A98-15DF-1903-6DBD-379A691D57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8BF837-6BFD-2027-B60C-5F502D758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B43942-7205-78DE-754B-C417A92D3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DB1444-9088-53CC-3FDA-5720F1F6B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5432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143765-DEDF-C8A3-688B-FC9E934C3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3ED1729-53FE-B492-6793-07966F3DCD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1DC456-4C37-647B-EBC5-DD3418C69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684CD9-AC6D-4BC4-F76C-AA74E5515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D8841D-C285-6F91-7F90-D9FDE9797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8330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71ED30-E6BB-29E5-EF85-5D83D23C4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4DC7E6-2293-C328-7184-AD0CF332E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9085B0-CF04-CB67-15C5-15491FEA2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040B7A-75E5-8212-C777-B3D9399EB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71B91B-285D-3132-F612-0589BA352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123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3123C4-8339-92A9-032F-110F9B092A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17E989-FCA1-A6C7-79D4-50B216D739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9A680D2-3E6A-ADD4-C9E1-3582C01DE3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0DE29ED-569B-7EB3-8B63-7D27D0E10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8D8529A-563E-A05B-62B0-B8FDA2510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1558FA9-10DC-9642-80BB-685D1D6A4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965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CECB09-3C09-B13B-D7A2-C405C93CE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113C2F-AF19-DD7E-1C40-68288E34F0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1A48D0D-6A84-70A7-80BF-35FD3D4611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CE68A2B-C3AB-6A9F-3ED7-DC604C8F7D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CF690A9-55D0-8FD8-34B4-B86589EE64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0D5E96D-2DD9-5097-F878-ACFA2AC15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C9718FE-9D47-86EC-0F9E-1CCFBAB7E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EEF7AE6-31A1-7831-F915-24CC1FA27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828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5C960C-1359-E665-9774-86DB853676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6ED9C1A-13D7-3809-1C37-E1A5CC3FE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309201F-27FC-1E82-2C1B-DADE055C2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AFA7613-391B-4057-BCDF-5237B0373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5318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EA41551-9FCF-36BA-8577-B03CF66C3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F785130-ABCD-0464-EAA9-821E749B6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C4A0F94-1998-63F0-0C06-43B13C11A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475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8FE82E-9C88-A519-2DE1-01B90D472A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AB4B1B-3C43-E1DE-90FC-9F667EC454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46A84C9-114B-D669-0C69-4CC1FECB48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45C28C-4690-D59F-2835-543D1419D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4E9BDF1-28EB-3016-47EB-63339F51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B864BF-77E6-C951-6D9C-A1163C992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317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C4E228-09F9-E2F9-08BF-60ACF39C70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ED63A1F-37AE-3E85-FB40-17AAB7BFA5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D4E6D08-45C3-F625-C38B-EEB3865A35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5114808-7B6D-43B6-6400-53B99C47D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5CA427-65ED-6EA2-9365-EC70EAFA8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97BB51-0A64-57B9-6834-E2D883734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4060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C8BEC8A-4C37-60DD-CEFC-EC9ADD8DF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F6425C4-4231-9957-A385-332F2470CC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247323-C7C8-2556-20ED-B1DEADF8B2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45E46-5334-4FFC-B447-BCDBF1380CF1}" type="datetimeFigureOut">
              <a:rPr lang="zh-CN" altLang="en-US" smtClean="0"/>
              <a:t>2023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3B7E07-3F33-A70F-0DC0-EBE1FA85BC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403BD2-19ED-874C-B377-A95568D597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57DDE-177E-4D28-89AC-B9E392B7F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939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BABFDCA9-5B1C-473B-9C29-38325F45BFE0}"/>
              </a:ext>
            </a:extLst>
          </p:cNvPr>
          <p:cNvGrpSpPr/>
          <p:nvPr/>
        </p:nvGrpSpPr>
        <p:grpSpPr>
          <a:xfrm>
            <a:off x="2703923" y="606671"/>
            <a:ext cx="5255847" cy="3661450"/>
            <a:chOff x="1979718" y="818812"/>
            <a:chExt cx="5255847" cy="366145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0C148524-082D-4D51-AE75-3FA71D83590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34572" y="1092060"/>
              <a:ext cx="2230755" cy="1673225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095BA72D-C83A-400B-99C7-44DE353213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2270" y="1090156"/>
              <a:ext cx="2224405" cy="1675129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BE28F31-6745-482D-B9D6-1442875F6EE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30127" y="2803862"/>
              <a:ext cx="2235200" cy="16764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9418C5F7-6E8B-4B3B-8FAD-9C4DB8C0922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2270" y="2805132"/>
              <a:ext cx="2233295" cy="167513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CE3C6F2-087C-4700-A961-E91519477D1E}"/>
                </a:ext>
              </a:extLst>
            </p:cNvPr>
            <p:cNvSpPr txBox="1"/>
            <p:nvPr/>
          </p:nvSpPr>
          <p:spPr>
            <a:xfrm>
              <a:off x="2114067" y="1790172"/>
              <a:ext cx="709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Palatino Linotype" panose="02040502050505030304" pitchFamily="18" charset="0"/>
                  <a:ea typeface="黑体" panose="02010609060101010101" pitchFamily="49" charset="-122"/>
                  <a:cs typeface="Arial" panose="020B0604020202020204" pitchFamily="34" charset="0"/>
                </a:rPr>
                <a:t>3177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19CD548-4CC5-4B05-96D3-DD92EEEF539C}"/>
                </a:ext>
              </a:extLst>
            </p:cNvPr>
            <p:cNvSpPr txBox="1"/>
            <p:nvPr/>
          </p:nvSpPr>
          <p:spPr>
            <a:xfrm>
              <a:off x="1979718" y="3472275"/>
              <a:ext cx="798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Palatino Linotype" panose="02040502050505030304" pitchFamily="18" charset="0"/>
                  <a:ea typeface="黑体" panose="02010609060101010101" pitchFamily="49" charset="-122"/>
                  <a:cs typeface="Arial" panose="020B0604020202020204" pitchFamily="34" charset="0"/>
                </a:rPr>
                <a:t>CCM45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5C9AAA5-4F6A-4027-B566-1651561C6EE4}"/>
                </a:ext>
              </a:extLst>
            </p:cNvPr>
            <p:cNvSpPr txBox="1"/>
            <p:nvPr/>
          </p:nvSpPr>
          <p:spPr>
            <a:xfrm>
              <a:off x="3704653" y="832817"/>
              <a:ext cx="5477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Palatino Linotype" panose="02040502050505030304" pitchFamily="18" charset="0"/>
                  <a:ea typeface="黑体" panose="02010609060101010101" pitchFamily="49" charset="-122"/>
                  <a:cs typeface="Arial" panose="020B0604020202020204" pitchFamily="34" charset="0"/>
                </a:rPr>
                <a:t>−Tp</a:t>
              </a:r>
              <a:endParaRPr kumimoji="0" lang="zh-CN" alt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B5832BF7-D8C1-4331-9D40-BA627D6D7515}"/>
                </a:ext>
              </a:extLst>
            </p:cNvPr>
            <p:cNvSpPr txBox="1"/>
            <p:nvPr/>
          </p:nvSpPr>
          <p:spPr>
            <a:xfrm>
              <a:off x="5873262" y="818812"/>
              <a:ext cx="709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Palatino Linotype" panose="02040502050505030304" pitchFamily="18" charset="0"/>
                  <a:ea typeface="黑体" panose="02010609060101010101" pitchFamily="49" charset="-122"/>
                  <a:cs typeface="Arial" panose="020B0604020202020204" pitchFamily="34" charset="0"/>
                </a:rPr>
                <a:t>+Tp</a:t>
              </a:r>
              <a:endParaRPr lang="zh-CN" altLang="en-US" sz="1200" b="1" i="1" dirty="0">
                <a:solidFill>
                  <a:prstClr val="black"/>
                </a:solidFill>
                <a:latin typeface="Palatino Linotype" panose="02040502050505030304" pitchFamily="18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49766407-C2E8-A62E-153E-F444C485AB9A}"/>
              </a:ext>
            </a:extLst>
          </p:cNvPr>
          <p:cNvSpPr txBox="1"/>
          <p:nvPr/>
        </p:nvSpPr>
        <p:spPr>
          <a:xfrm>
            <a:off x="1192378" y="4572000"/>
            <a:ext cx="955365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Root colonization by </a:t>
            </a:r>
            <a:r>
              <a:rPr lang="en-US" altLang="zh-CN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urpurogenus</a:t>
            </a:r>
            <a:r>
              <a:rPr lang="en-US" altLang="zh-CN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was determined by trypan blue staining. Maize seedling roots grown without </a:t>
            </a:r>
            <a:r>
              <a:rPr lang="en-US" altLang="zh-CN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urpurogenus</a:t>
            </a:r>
            <a:r>
              <a:rPr lang="en-US" altLang="zh-CN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were used as the negative control. The arrows showed the microsclerotia-like structures as a result of </a:t>
            </a:r>
            <a:r>
              <a:rPr lang="en-US" altLang="zh-CN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urpurogenus</a:t>
            </a:r>
            <a:r>
              <a:rPr lang="en-US" altLang="zh-CN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olonization in maize roots. 31778 and CCM454 are low-P-sensitive and -tolerant inbred lines of maize, respectively. Bar = 50 </a:t>
            </a:r>
            <a:r>
              <a:rPr lang="en-US" altLang="zh-CN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0546D9C8-6DD5-DF8E-F0F0-4410E248BF1C}"/>
              </a:ext>
            </a:extLst>
          </p:cNvPr>
          <p:cNvCxnSpPr/>
          <p:nvPr/>
        </p:nvCxnSpPr>
        <p:spPr>
          <a:xfrm flipH="1">
            <a:off x="6678778" y="3191423"/>
            <a:ext cx="256032" cy="25420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24FA2AB4-2DFC-56C3-F71E-62E9FB47A5ED}"/>
              </a:ext>
            </a:extLst>
          </p:cNvPr>
          <p:cNvCxnSpPr>
            <a:cxnSpLocks/>
          </p:cNvCxnSpPr>
          <p:nvPr/>
        </p:nvCxnSpPr>
        <p:spPr>
          <a:xfrm flipH="1">
            <a:off x="7471258" y="980902"/>
            <a:ext cx="351018" cy="144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7462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4</TotalTime>
  <Words>75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Palatino Linotype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孙 青</dc:creator>
  <cp:lastModifiedBy>孙 青</cp:lastModifiedBy>
  <cp:revision>27</cp:revision>
  <dcterms:created xsi:type="dcterms:W3CDTF">2022-10-19T06:15:00Z</dcterms:created>
  <dcterms:modified xsi:type="dcterms:W3CDTF">2023-07-25T11:48:21Z</dcterms:modified>
</cp:coreProperties>
</file>